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61" r:id="rId3"/>
    <p:sldId id="262" r:id="rId4"/>
    <p:sldId id="272" r:id="rId5"/>
    <p:sldId id="273" r:id="rId6"/>
    <p:sldId id="275" r:id="rId7"/>
    <p:sldId id="276" r:id="rId8"/>
    <p:sldId id="277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50" autoAdjust="0"/>
    <p:restoredTop sz="96346"/>
  </p:normalViewPr>
  <p:slideViewPr>
    <p:cSldViewPr snapToGrid="0">
      <p:cViewPr varScale="1">
        <p:scale>
          <a:sx n="139" d="100"/>
          <a:sy n="139" d="100"/>
        </p:scale>
        <p:origin x="616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reno Cortes, Eider F., M.D." userId="1a568542-25ec-4a7f-b577-82da0c9cb855" providerId="ADAL" clId="{EC7B30E2-4C73-B44D-BF55-6DDCB5BE2F85}"/>
    <pc:docChg chg="custSel modSld">
      <pc:chgData name="Moreno Cortes, Eider F., M.D." userId="1a568542-25ec-4a7f-b577-82da0c9cb855" providerId="ADAL" clId="{EC7B30E2-4C73-B44D-BF55-6DDCB5BE2F85}" dt="2023-07-21T18:42:16.758" v="62" actId="114"/>
      <pc:docMkLst>
        <pc:docMk/>
      </pc:docMkLst>
      <pc:sldChg chg="modSp mod">
        <pc:chgData name="Moreno Cortes, Eider F., M.D." userId="1a568542-25ec-4a7f-b577-82da0c9cb855" providerId="ADAL" clId="{EC7B30E2-4C73-B44D-BF55-6DDCB5BE2F85}" dt="2023-07-21T18:42:16.758" v="62" actId="114"/>
        <pc:sldMkLst>
          <pc:docMk/>
          <pc:sldMk cId="2250881914" sldId="275"/>
        </pc:sldMkLst>
        <pc:spChg chg="mod">
          <ac:chgData name="Moreno Cortes, Eider F., M.D." userId="1a568542-25ec-4a7f-b577-82da0c9cb855" providerId="ADAL" clId="{EC7B30E2-4C73-B44D-BF55-6DDCB5BE2F85}" dt="2023-07-21T18:42:16.758" v="62" actId="114"/>
          <ac:spMkLst>
            <pc:docMk/>
            <pc:sldMk cId="2250881914" sldId="275"/>
            <ac:spMk id="2" creationId="{224CB5FA-032A-B473-FFB7-108F11570B88}"/>
          </ac:spMkLst>
        </pc:spChg>
        <pc:graphicFrameChg chg="modGraphic">
          <ac:chgData name="Moreno Cortes, Eider F., M.D." userId="1a568542-25ec-4a7f-b577-82da0c9cb855" providerId="ADAL" clId="{EC7B30E2-4C73-B44D-BF55-6DDCB5BE2F85}" dt="2023-07-21T18:41:44.572" v="6" actId="20577"/>
          <ac:graphicFrameMkLst>
            <pc:docMk/>
            <pc:sldMk cId="2250881914" sldId="275"/>
            <ac:graphicFrameMk id="4" creationId="{2D8C5531-0D3E-FDE9-8921-BF0621FD7F74}"/>
          </ac:graphicFrameMkLst>
        </pc:graphicFrameChg>
      </pc:sldChg>
    </pc:docChg>
  </pc:docChgLst>
  <pc:docChgLst>
    <pc:chgData name="Moreno Cortes, Eider F., M.D." userId="1a568542-25ec-4a7f-b577-82da0c9cb855" providerId="ADAL" clId="{5C2AD0E4-7703-DC47-90BE-FE85E6D2D292}"/>
    <pc:docChg chg="custSel modSld">
      <pc:chgData name="Moreno Cortes, Eider F., M.D." userId="1a568542-25ec-4a7f-b577-82da0c9cb855" providerId="ADAL" clId="{5C2AD0E4-7703-DC47-90BE-FE85E6D2D292}" dt="2023-07-05T19:11:00.232" v="27" actId="14100"/>
      <pc:docMkLst>
        <pc:docMk/>
      </pc:docMkLst>
      <pc:sldChg chg="modSp mod">
        <pc:chgData name="Moreno Cortes, Eider F., M.D." userId="1a568542-25ec-4a7f-b577-82da0c9cb855" providerId="ADAL" clId="{5C2AD0E4-7703-DC47-90BE-FE85E6D2D292}" dt="2023-07-05T19:11:00.232" v="27" actId="14100"/>
        <pc:sldMkLst>
          <pc:docMk/>
          <pc:sldMk cId="925989106" sldId="256"/>
        </pc:sldMkLst>
        <pc:spChg chg="mod">
          <ac:chgData name="Moreno Cortes, Eider F., M.D." userId="1a568542-25ec-4a7f-b577-82da0c9cb855" providerId="ADAL" clId="{5C2AD0E4-7703-DC47-90BE-FE85E6D2D292}" dt="2023-07-05T19:11:00.232" v="27" actId="14100"/>
          <ac:spMkLst>
            <pc:docMk/>
            <pc:sldMk cId="925989106" sldId="256"/>
            <ac:spMk id="2" creationId="{EAA4EB0E-88CA-43EB-3A33-03B8141F9D22}"/>
          </ac:spMkLst>
        </pc:spChg>
        <pc:spChg chg="mod">
          <ac:chgData name="Moreno Cortes, Eider F., M.D." userId="1a568542-25ec-4a7f-b577-82da0c9cb855" providerId="ADAL" clId="{5C2AD0E4-7703-DC47-90BE-FE85E6D2D292}" dt="2023-07-05T19:10:55.857" v="25" actId="1076"/>
          <ac:spMkLst>
            <pc:docMk/>
            <pc:sldMk cId="925989106" sldId="256"/>
            <ac:spMk id="3" creationId="{457259DF-D024-81BA-B30B-04E6F68F805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D76AB9-AC39-49BE-98E0-0FD3EE181034}" type="datetimeFigureOut">
              <a:rPr lang="en-US" smtClean="0"/>
              <a:t>7/2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BEFE95-03B7-46D4-B041-5808A67B3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8455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55E9B-9A07-44C9-848E-FB6D4A74FB5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8228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6C6CED-82FF-8DC1-8B91-F106E3EECE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8B04654-550F-D3F2-391B-B0A27BF043A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873626-5E29-8B3D-A0C8-1A910A3E6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3102FC-9DBF-A67E-53E9-5B485B01A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5E757C-2C08-4610-FD24-E237BC80C0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745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E30EF0-3968-9C93-2437-F1D1325B03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275222-49DD-AFC2-2F75-25DED7948F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9CC85E-F16D-E9D2-09D7-1AA453538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2614E9-4831-D1DD-CB0B-80B1641C22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4160BA-D4D2-EC74-52C3-875FC578C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321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0B6CD9-F5BA-DC8E-DE94-33BA78D05A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9450AF-F508-83B0-9075-F6A01AEB01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0FC07D-A3C2-3156-5FDC-F9B583DCB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47E9C8-6536-2BED-6C2B-BA2D8E889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D102B9-05E9-44BE-1091-17590257D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254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730B66-210B-1714-9111-7673BBCBC4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16808E-ED2E-58D1-7903-CB74A0E85E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4D485B-A833-E9FC-3FB2-A06D1054B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5F64AA-46A9-E200-3323-5568DDE78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F3F1D6-9238-EFCC-B7B8-6C8925054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283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8E12FF-88B8-3FBA-76E2-C0ED6301ED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33B630-498F-1682-412A-4F33D0268A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1919EF-54AF-9069-7516-8185102D3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200FB-5EEC-54F6-50BF-614A1E1D2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5AD405-AC6E-2081-245E-37EEE497B6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583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742B4-DDD1-85CE-DC44-21C6B54025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52EA21-B663-E131-4F9A-049B9F0489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63A502-9DF6-5BAF-13FB-9A5732BB79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E3A180-4AD4-F975-4B40-CE89EF50B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474787-9FA4-5B2A-A949-91EF3A0E1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6E9E19-EFC0-D53E-14F3-780A80F4E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486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F18426-D29F-A0CA-386F-A012316065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4C06C0-3C42-5B70-1B01-302A6FDD13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3E860D-9968-8E90-DB17-9227CBC054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CEDC2F8-6309-2001-9831-67E60F9376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30A96C-7E19-1035-3A98-B35853F92E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662CCC-978E-CE32-FDF2-E9DC0385C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38B8D3D-0CEB-7AC9-9DAA-94AB75E0B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A623E8E-1ECD-5FAD-6941-3CE14BEEFB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379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A5FB6F-D47F-CA65-4BFC-1C4474D367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A33290-1450-5784-E125-14B7075D7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6C5373-55F3-A36D-43C8-ADA36643C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D450954-0C48-DF0D-8E2B-4EEAB3DC1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334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B39FEA-6714-0B8C-09D3-CC6AAC084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882E5A-B450-8CE2-4FB9-EB4426870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B54BC8-4AAC-3D6D-4336-6C2D1D7A7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724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2F1715-E864-DDA3-9D49-7B267CC35C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458828-5691-F427-F012-167281C946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6499FD-CFE4-829C-C484-7ABACED5F8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6EBE14-D413-E8F2-E63B-08388D1C7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C2B841-CE03-CDE9-1C37-47BDDB00F8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AFD61B-48BD-6DEC-7866-722BBAEA4E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410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DA3219-7A84-2EBF-136E-21277B9837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DBF8B6-84C1-1071-CB4A-A9C8FCF440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69C9BF-BD7A-38D4-8F7F-32D8EC80D6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24D5F9-BFFD-3ABF-608C-1360A73CA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BF36E7-20E3-E099-224F-F35D4D644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945002-D3A1-EDC2-E0DE-BFB85D972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177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079FDB-B4F4-DD07-E0A5-A14B64D04D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E864E7-8879-8D1B-0AF9-E4110C8F57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20423D-851F-81E8-ADE7-DAED0BE7C6C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97F3F4-ADE1-483B-A62E-76159E22DC8A}" type="datetimeFigureOut">
              <a:rPr lang="en-US" smtClean="0"/>
              <a:t>7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E058DD-3C98-373B-BD63-BF4B85D86F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A1ACC7-BFBA-C84C-5B62-E785C3CC1E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077A1-8A1F-4221-9F27-1D0D8728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0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A4EB0E-88CA-43EB-3A33-03B8141F9D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435608"/>
            <a:ext cx="9144000" cy="3253931"/>
          </a:xfrm>
        </p:spPr>
        <p:txBody>
          <a:bodyPr>
            <a:normAutofit fontScale="90000"/>
          </a:bodyPr>
          <a:lstStyle/>
          <a:p>
            <a:r>
              <a:rPr lang="en-US" dirty="0"/>
              <a:t> </a:t>
            </a:r>
            <a:br>
              <a:rPr lang="en-US" dirty="0"/>
            </a:br>
            <a:r>
              <a:rPr lang="en-US" dirty="0"/>
              <a:t>ICOS and OX40 tandem co-stimulation enhances CAR T-cell cytotoxicity and promotes a T-cell persistence phenotyp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57259DF-D024-81BA-B30B-04E6F68F80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4827334"/>
            <a:ext cx="9144000" cy="1655762"/>
          </a:xfrm>
        </p:spPr>
        <p:txBody>
          <a:bodyPr/>
          <a:lstStyle/>
          <a:p>
            <a:r>
              <a:rPr lang="en-US" dirty="0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9259891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raphical user interface, application, Teams&#10;&#10;Description automatically generated">
            <a:extLst>
              <a:ext uri="{FF2B5EF4-FFF2-40B4-BE49-F238E27FC236}">
                <a16:creationId xmlns:a16="http://schemas.microsoft.com/office/drawing/2014/main" id="{7AA69D12-4C2C-8041-B200-D498129A859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729"/>
          <a:stretch/>
        </p:blipFill>
        <p:spPr>
          <a:xfrm>
            <a:off x="2375588" y="1523998"/>
            <a:ext cx="7122450" cy="2132090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9148AEEF-FE11-FF43-9C90-1AC7839509CA}"/>
              </a:ext>
            </a:extLst>
          </p:cNvPr>
          <p:cNvCxnSpPr>
            <a:cxnSpLocks/>
          </p:cNvCxnSpPr>
          <p:nvPr/>
        </p:nvCxnSpPr>
        <p:spPr>
          <a:xfrm>
            <a:off x="4486865" y="2518368"/>
            <a:ext cx="3048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9D4C388B-AAF2-6D45-8696-EABC7E00CF95}"/>
              </a:ext>
            </a:extLst>
          </p:cNvPr>
          <p:cNvCxnSpPr/>
          <p:nvPr/>
        </p:nvCxnSpPr>
        <p:spPr>
          <a:xfrm>
            <a:off x="6889052" y="2518368"/>
            <a:ext cx="4572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A62997B7-9867-704C-9A8E-ECF473853B2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39"/>
          <a:stretch/>
        </p:blipFill>
        <p:spPr>
          <a:xfrm>
            <a:off x="3635221" y="3894841"/>
            <a:ext cx="4572000" cy="1915971"/>
          </a:xfrm>
          <a:prstGeom prst="rect">
            <a:avLst/>
          </a:prstGeom>
        </p:spPr>
      </p:pic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1ADE5F6C-3176-3B4D-8467-24EE3E3BC983}"/>
              </a:ext>
            </a:extLst>
          </p:cNvPr>
          <p:cNvCxnSpPr>
            <a:cxnSpLocks/>
          </p:cNvCxnSpPr>
          <p:nvPr/>
        </p:nvCxnSpPr>
        <p:spPr>
          <a:xfrm flipH="1">
            <a:off x="5632013" y="4876796"/>
            <a:ext cx="6096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ctor: Elbow 5">
            <a:extLst>
              <a:ext uri="{FF2B5EF4-FFF2-40B4-BE49-F238E27FC236}">
                <a16:creationId xmlns:a16="http://schemas.microsoft.com/office/drawing/2014/main" id="{7FC2F191-0DEA-336D-BF48-0B764435F8CF}"/>
              </a:ext>
            </a:extLst>
          </p:cNvPr>
          <p:cNvCxnSpPr>
            <a:cxnSpLocks/>
            <a:endCxn id="12" idx="3"/>
          </p:cNvCxnSpPr>
          <p:nvPr/>
        </p:nvCxnSpPr>
        <p:spPr>
          <a:xfrm rot="5400000">
            <a:off x="7934331" y="4001405"/>
            <a:ext cx="1124312" cy="578532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667B090-19F5-6184-A445-EFE3BE5F3E06}"/>
                  </a:ext>
                </a:extLst>
              </p:cNvPr>
              <p:cNvSpPr txBox="1"/>
              <p:nvPr/>
            </p:nvSpPr>
            <p:spPr>
              <a:xfrm>
                <a:off x="3370210" y="5977138"/>
                <a:ext cx="5415543" cy="444074"/>
              </a:xfrm>
              <a:prstGeom prst="rect">
                <a:avLst/>
              </a:prstGeom>
              <a:solidFill>
                <a:srgbClr val="000000">
                  <a:alpha val="50000"/>
                </a:srgbClr>
              </a:solidFill>
              <a:ln>
                <a:noFill/>
              </a:ln>
            </p:spPr>
            <p:txBody>
              <a:bodyPr wrap="square" lIns="0" tIns="0" rIns="0" bIns="0" rtlCol="0">
                <a:noAutofit/>
              </a:bodyPr>
              <a:lstStyle/>
              <a:p>
                <a:pPr algn="ctr">
                  <a:spcAft>
                    <a:spcPts val="600"/>
                  </a:spcAft>
                </a:pPr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f>
                        <m:fPr>
                          <m:ctrlPr>
                            <a:rPr lang="en-CO" sz="120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</m:ctrlPr>
                        </m:fPr>
                        <m:num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#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𝐸𝑣𝑒𝑛𝑡𝑠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 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𝑎𝑡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 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𝐹𝑙𝑜𝑤𝑗𝑜</m:t>
                          </m:r>
                        </m:num>
                        <m:den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# 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𝐵𝑒𝑎𝑑𝑠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 (10.000)</m:t>
                          </m:r>
                        </m:den>
                      </m:f>
                      <m:r>
                        <a:rPr lang="en-US" sz="1200" b="0" i="1" smtClean="0">
                          <a:solidFill>
                            <a:srgbClr val="FFFFFF"/>
                          </a:solidFill>
                          <a:latin typeface="Cambria Math" panose="02040503050406030204" pitchFamily="18" charset="0"/>
                        </a:rPr>
                        <m:t>∗</m:t>
                      </m:r>
                      <m:f>
                        <m:fPr>
                          <m:ctrlP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</m:ctrlPr>
                        </m:fPr>
                        <m:num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49,500 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𝑏𝑒𝑎𝑑𝑠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 (50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𝑢𝑙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)</m:t>
                          </m:r>
                        </m:num>
                        <m:den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𝑉𝑜𝑙𝑢𝑚𝑒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 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𝑜𝑓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 </m:t>
                          </m:r>
                          <m:r>
                            <a:rPr lang="en-US" sz="1200" b="0" i="1" smtClean="0">
                              <a:solidFill>
                                <a:srgbClr val="FFFFFF"/>
                              </a:solidFill>
                              <a:latin typeface="Cambria Math" panose="02040503050406030204" pitchFamily="18" charset="0"/>
                            </a:rPr>
                            <m:t>𝐵𝑙𝑜𝑜𝑑</m:t>
                          </m:r>
                        </m:den>
                      </m:f>
                    </m:oMath>
                  </m:oMathPara>
                </a14:m>
                <a:endParaRPr lang="en-CO" sz="1200">
                  <a:solidFill>
                    <a:srgbClr val="FFFFFF"/>
                  </a:solidFill>
                </a:endParaRPr>
              </a:p>
            </p:txBody>
          </p:sp>
        </mc:Choice>
        <mc:Fallback xmlns="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667B090-19F5-6184-A445-EFE3BE5F3E0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370210" y="5977138"/>
                <a:ext cx="5415543" cy="444074"/>
              </a:xfrm>
              <a:prstGeom prst="rect">
                <a:avLst/>
              </a:prstGeom>
              <a:blipFill>
                <a:blip r:embed="rId5"/>
                <a:stretch>
                  <a:fillRect/>
                </a:stretch>
              </a:blipFill>
              <a:ln>
                <a:noFill/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" name="Title 1">
            <a:extLst>
              <a:ext uri="{FF2B5EF4-FFF2-40B4-BE49-F238E27FC236}">
                <a16:creationId xmlns:a16="http://schemas.microsoft.com/office/drawing/2014/main" id="{8ADE8E55-A614-8621-BE23-6122A9AFE7E7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b="1" dirty="0">
                <a:latin typeface="+mn-lt"/>
              </a:rPr>
              <a:t>Supplementary Figure 1. </a:t>
            </a:r>
            <a:r>
              <a:rPr lang="en-US" sz="2400" dirty="0">
                <a:latin typeface="+mn-lt"/>
              </a:rPr>
              <a:t>In vivo – CAR detection via Flow cytometry gate strategy</a:t>
            </a:r>
          </a:p>
        </p:txBody>
      </p:sp>
    </p:spTree>
    <p:extLst>
      <p:ext uri="{BB962C8B-B14F-4D97-AF65-F5344CB8AC3E}">
        <p14:creationId xmlns:p14="http://schemas.microsoft.com/office/powerpoint/2010/main" val="25046472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19760CE2-4B8B-9E36-8643-2373D0C3E86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038688337"/>
              </p:ext>
            </p:extLst>
          </p:nvPr>
        </p:nvGraphicFramePr>
        <p:xfrm>
          <a:off x="601584" y="1133080"/>
          <a:ext cx="10752216" cy="519176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3104147">
                  <a:extLst>
                    <a:ext uri="{9D8B030D-6E8A-4147-A177-3AD203B41FA5}">
                      <a16:colId xmlns:a16="http://schemas.microsoft.com/office/drawing/2014/main" val="2199697165"/>
                    </a:ext>
                  </a:extLst>
                </a:gridCol>
                <a:gridCol w="2271961">
                  <a:extLst>
                    <a:ext uri="{9D8B030D-6E8A-4147-A177-3AD203B41FA5}">
                      <a16:colId xmlns:a16="http://schemas.microsoft.com/office/drawing/2014/main" val="3449231992"/>
                    </a:ext>
                  </a:extLst>
                </a:gridCol>
                <a:gridCol w="2688054">
                  <a:extLst>
                    <a:ext uri="{9D8B030D-6E8A-4147-A177-3AD203B41FA5}">
                      <a16:colId xmlns:a16="http://schemas.microsoft.com/office/drawing/2014/main" val="628694489"/>
                    </a:ext>
                  </a:extLst>
                </a:gridCol>
                <a:gridCol w="2688054">
                  <a:extLst>
                    <a:ext uri="{9D8B030D-6E8A-4147-A177-3AD203B41FA5}">
                      <a16:colId xmlns:a16="http://schemas.microsoft.com/office/drawing/2014/main" val="301708505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l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ompan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atalog Numb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26146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D45 Alexa 700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fontAlgn="base"/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I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60566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74857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 CD3 PerCP-Cy5.5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UCHT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60835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1329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 CD4 BV786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K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63877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588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 CD8 APC-H7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IT8A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66855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31172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 CD45RA APC  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I100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50855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71262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 CD62L Bv42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REG-56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63862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52873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 CD279 (PD-1) BV650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H12.1 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6410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8946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 CD223(LAG-3) BV480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47-530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46609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12358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 CD366 (TIM-3) BUV737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D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48820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45380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 TIGIT BUV395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4118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41182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45654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xable Viability Stain (FVS) 510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N/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D Biosci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64406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44469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huROR1 protein Biotinylat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N/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Acro Biosystem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O1-H82E6-25u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306639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Anti-FMC63 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Acro Biosystem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M3-PY54A2-25tests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2173723"/>
                  </a:ext>
                </a:extLst>
              </a:tr>
            </a:tbl>
          </a:graphicData>
        </a:graphic>
      </p:graphicFrame>
      <p:sp>
        <p:nvSpPr>
          <p:cNvPr id="3" name="Title 1">
            <a:extLst>
              <a:ext uri="{FF2B5EF4-FFF2-40B4-BE49-F238E27FC236}">
                <a16:creationId xmlns:a16="http://schemas.microsoft.com/office/drawing/2014/main" id="{B551233E-6790-F424-BF4A-A83B2894085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b="1" dirty="0">
                <a:latin typeface="+mn-lt"/>
              </a:rPr>
              <a:t>Supplementary Table 1. </a:t>
            </a:r>
            <a:r>
              <a:rPr lang="en-US" sz="2400" dirty="0">
                <a:latin typeface="+mn-lt"/>
              </a:rPr>
              <a:t>Flow cytometry - Antibody list</a:t>
            </a:r>
          </a:p>
        </p:txBody>
      </p:sp>
    </p:spTree>
    <p:extLst>
      <p:ext uri="{BB962C8B-B14F-4D97-AF65-F5344CB8AC3E}">
        <p14:creationId xmlns:p14="http://schemas.microsoft.com/office/powerpoint/2010/main" val="10486632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4DF9D1-5224-7299-C479-4B5884F322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+mn-lt"/>
              </a:rPr>
              <a:t>Supplementary Figure 2. </a:t>
            </a:r>
            <a:r>
              <a:rPr lang="en-US" sz="2400" dirty="0">
                <a:latin typeface="+mn-lt"/>
              </a:rPr>
              <a:t>ROR1 3G CAR expression</a:t>
            </a:r>
          </a:p>
        </p:txBody>
      </p:sp>
      <p:pic>
        <p:nvPicPr>
          <p:cNvPr id="9" name="Content Placeholder 8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5E18C741-51E5-A16D-6299-770A7E8C6F4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5" t="-925" b="17203"/>
          <a:stretch/>
        </p:blipFill>
        <p:spPr>
          <a:xfrm>
            <a:off x="774915" y="2053525"/>
            <a:ext cx="11032287" cy="2805189"/>
          </a:xfrm>
        </p:spPr>
      </p:pic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6055939-9F6C-0C0A-F0D5-9FF0F2EDE645}"/>
              </a:ext>
            </a:extLst>
          </p:cNvPr>
          <p:cNvCxnSpPr/>
          <p:nvPr/>
        </p:nvCxnSpPr>
        <p:spPr>
          <a:xfrm flipV="1">
            <a:off x="720671" y="2557220"/>
            <a:ext cx="0" cy="209227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3096861B-8A61-0450-DE5B-7162750FAFFE}"/>
              </a:ext>
            </a:extLst>
          </p:cNvPr>
          <p:cNvSpPr txBox="1"/>
          <p:nvPr/>
        </p:nvSpPr>
        <p:spPr>
          <a:xfrm rot="16200000">
            <a:off x="174367" y="341868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C-A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CEBF1E70-3714-2CDF-B39B-433E890265B4}"/>
              </a:ext>
            </a:extLst>
          </p:cNvPr>
          <p:cNvCxnSpPr>
            <a:cxnSpLocks/>
          </p:cNvCxnSpPr>
          <p:nvPr/>
        </p:nvCxnSpPr>
        <p:spPr>
          <a:xfrm>
            <a:off x="1131376" y="4912964"/>
            <a:ext cx="1053109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808950C9-FFDA-EC10-119E-72A42A0B8D4C}"/>
              </a:ext>
            </a:extLst>
          </p:cNvPr>
          <p:cNvSpPr txBox="1"/>
          <p:nvPr/>
        </p:nvSpPr>
        <p:spPr>
          <a:xfrm>
            <a:off x="4626244" y="4912964"/>
            <a:ext cx="25983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R1 CAR Expression - PE</a:t>
            </a:r>
          </a:p>
        </p:txBody>
      </p:sp>
    </p:spTree>
    <p:extLst>
      <p:ext uri="{BB962C8B-B14F-4D97-AF65-F5344CB8AC3E}">
        <p14:creationId xmlns:p14="http://schemas.microsoft.com/office/powerpoint/2010/main" val="38373654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0C323953-2FCD-F6FD-6CEF-F695CF7162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+mn-lt"/>
              </a:rPr>
              <a:t>Supplementary Figure 3. </a:t>
            </a:r>
            <a:r>
              <a:rPr lang="en-US" sz="2400" dirty="0">
                <a:latin typeface="+mn-lt"/>
              </a:rPr>
              <a:t>Mice weight and tumor engraftments curves</a:t>
            </a:r>
          </a:p>
        </p:txBody>
      </p:sp>
      <p:pic>
        <p:nvPicPr>
          <p:cNvPr id="12" name="Content Placeholder 11" descr="Chart, line chart&#10;&#10;Description automatically generated">
            <a:extLst>
              <a:ext uri="{FF2B5EF4-FFF2-40B4-BE49-F238E27FC236}">
                <a16:creationId xmlns:a16="http://schemas.microsoft.com/office/drawing/2014/main" id="{27356808-BC7F-D2E0-2322-DA8243DD5EE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420" r="12017"/>
          <a:stretch/>
        </p:blipFill>
        <p:spPr>
          <a:xfrm>
            <a:off x="5684003" y="2258567"/>
            <a:ext cx="5128777" cy="3307409"/>
          </a:xfrm>
        </p:spPr>
      </p:pic>
      <p:pic>
        <p:nvPicPr>
          <p:cNvPr id="14" name="Picture 13" descr="A picture containing dark, light&#10;&#10;Description automatically generated">
            <a:extLst>
              <a:ext uri="{FF2B5EF4-FFF2-40B4-BE49-F238E27FC236}">
                <a16:creationId xmlns:a16="http://schemas.microsoft.com/office/drawing/2014/main" id="{CFF911FA-6B87-D3FE-3D0D-9DF0F23FC07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345"/>
          <a:stretch/>
        </p:blipFill>
        <p:spPr>
          <a:xfrm>
            <a:off x="329662" y="2098877"/>
            <a:ext cx="4808027" cy="32004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86F0FC19-CF06-EF1F-A390-A8D7FA8A5651}"/>
              </a:ext>
            </a:extLst>
          </p:cNvPr>
          <p:cNvSpPr txBox="1"/>
          <p:nvPr/>
        </p:nvSpPr>
        <p:spPr>
          <a:xfrm>
            <a:off x="10763794" y="2756262"/>
            <a:ext cx="476412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/>
              <a:t>UT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748DE3A-F5F0-935F-4B1C-3ACF22440BB9}"/>
              </a:ext>
            </a:extLst>
          </p:cNvPr>
          <p:cNvSpPr txBox="1"/>
          <p:nvPr/>
        </p:nvSpPr>
        <p:spPr>
          <a:xfrm>
            <a:off x="10763794" y="3000102"/>
            <a:ext cx="779381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/>
              <a:t>ROR1-B𝜁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03F38A8-A4C5-0397-3C34-EC035B5FB072}"/>
              </a:ext>
            </a:extLst>
          </p:cNvPr>
          <p:cNvSpPr txBox="1"/>
          <p:nvPr/>
        </p:nvSpPr>
        <p:spPr>
          <a:xfrm>
            <a:off x="10763794" y="3251226"/>
            <a:ext cx="840295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/>
              <a:t>ROR1-IO𝜁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5B0EF85-F641-A21B-811E-DCC26FE60A08}"/>
              </a:ext>
            </a:extLst>
          </p:cNvPr>
          <p:cNvSpPr txBox="1"/>
          <p:nvPr/>
        </p:nvSpPr>
        <p:spPr>
          <a:xfrm>
            <a:off x="10763794" y="3483080"/>
            <a:ext cx="76655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00" dirty="0"/>
              <a:t>CD19-B𝜁</a:t>
            </a:r>
          </a:p>
        </p:txBody>
      </p:sp>
    </p:spTree>
    <p:extLst>
      <p:ext uri="{BB962C8B-B14F-4D97-AF65-F5344CB8AC3E}">
        <p14:creationId xmlns:p14="http://schemas.microsoft.com/office/powerpoint/2010/main" val="32316546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0C323953-2FCD-F6FD-6CEF-F695CF7162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+mn-lt"/>
              </a:rPr>
              <a:t>Supplementary Table 2. </a:t>
            </a:r>
            <a:r>
              <a:rPr lang="en-US" sz="2400" dirty="0">
                <a:latin typeface="+mn-lt"/>
              </a:rPr>
              <a:t>T</a:t>
            </a:r>
            <a:r>
              <a:rPr lang="en-US" sz="2400" baseline="-25000" dirty="0">
                <a:latin typeface="+mn-lt"/>
              </a:rPr>
              <a:t>CM</a:t>
            </a:r>
            <a:r>
              <a:rPr lang="en-US" sz="2400" dirty="0">
                <a:latin typeface="+mn-lt"/>
              </a:rPr>
              <a:t>/T</a:t>
            </a:r>
            <a:r>
              <a:rPr lang="en-US" sz="2400" baseline="-25000" dirty="0">
                <a:latin typeface="+mn-lt"/>
              </a:rPr>
              <a:t>EM</a:t>
            </a:r>
            <a:r>
              <a:rPr lang="en-US" sz="2400" dirty="0">
                <a:latin typeface="+mn-lt"/>
              </a:rPr>
              <a:t> Ratio on CD4+ and CD8+ 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D8C5531-0D3E-FDE9-8921-BF0621FD7F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4926015"/>
              </p:ext>
            </p:extLst>
          </p:nvPr>
        </p:nvGraphicFramePr>
        <p:xfrm>
          <a:off x="2453712" y="2399957"/>
          <a:ext cx="7116316" cy="1758103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357700">
                  <a:extLst>
                    <a:ext uri="{9D8B030D-6E8A-4147-A177-3AD203B41FA5}">
                      <a16:colId xmlns:a16="http://schemas.microsoft.com/office/drawing/2014/main" val="1005569201"/>
                    </a:ext>
                  </a:extLst>
                </a:gridCol>
                <a:gridCol w="1576408">
                  <a:extLst>
                    <a:ext uri="{9D8B030D-6E8A-4147-A177-3AD203B41FA5}">
                      <a16:colId xmlns:a16="http://schemas.microsoft.com/office/drawing/2014/main" val="2358195926"/>
                    </a:ext>
                  </a:extLst>
                </a:gridCol>
                <a:gridCol w="1368051">
                  <a:extLst>
                    <a:ext uri="{9D8B030D-6E8A-4147-A177-3AD203B41FA5}">
                      <a16:colId xmlns:a16="http://schemas.microsoft.com/office/drawing/2014/main" val="4086091335"/>
                    </a:ext>
                  </a:extLst>
                </a:gridCol>
                <a:gridCol w="1368051">
                  <a:extLst>
                    <a:ext uri="{9D8B030D-6E8A-4147-A177-3AD203B41FA5}">
                      <a16:colId xmlns:a16="http://schemas.microsoft.com/office/drawing/2014/main" val="1274872128"/>
                    </a:ext>
                  </a:extLst>
                </a:gridCol>
                <a:gridCol w="1446106">
                  <a:extLst>
                    <a:ext uri="{9D8B030D-6E8A-4147-A177-3AD203B41FA5}">
                      <a16:colId xmlns:a16="http://schemas.microsoft.com/office/drawing/2014/main" val="2229185635"/>
                    </a:ext>
                  </a:extLst>
                </a:gridCol>
              </a:tblGrid>
              <a:tr h="6134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T</a:t>
                      </a:r>
                      <a:r>
                        <a:rPr lang="en-US" sz="2400" b="1" u="none" strike="noStrike" baseline="-25000" dirty="0">
                          <a:effectLst/>
                        </a:rPr>
                        <a:t>CM</a:t>
                      </a:r>
                      <a:r>
                        <a:rPr lang="en-US" sz="2400" b="1" u="none" strike="noStrike" dirty="0">
                          <a:effectLst/>
                        </a:rPr>
                        <a:t>/T</a:t>
                      </a:r>
                      <a:r>
                        <a:rPr lang="en-US" sz="2400" b="1" u="none" strike="noStrike" baseline="-25000" dirty="0">
                          <a:effectLst/>
                        </a:rPr>
                        <a:t>EM</a:t>
                      </a:r>
                      <a:r>
                        <a:rPr lang="en-US" sz="2400" b="1" u="none" strike="noStrike" dirty="0">
                          <a:effectLst/>
                        </a:rPr>
                        <a:t>  Ratio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ROR1-B𝜁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ROR1-IO𝜁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ROR1-IB𝜁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ROR1-28B𝜁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587514"/>
                  </a:ext>
                </a:extLst>
              </a:tr>
              <a:tr h="5085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CD4 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2.63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4.82*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2.61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1.53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23652871"/>
                  </a:ext>
                </a:extLst>
              </a:tr>
              <a:tr h="5085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CD8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1.58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2.15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2.00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1.34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41449800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24CB5FA-032A-B473-FFB7-108F11570B88}"/>
              </a:ext>
            </a:extLst>
          </p:cNvPr>
          <p:cNvSpPr txBox="1"/>
          <p:nvPr/>
        </p:nvSpPr>
        <p:spPr>
          <a:xfrm>
            <a:off x="974505" y="5045529"/>
            <a:ext cx="1065292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table 2. </a:t>
            </a:r>
            <a:r>
              <a:rPr lang="en-US" sz="1800" b="1" dirty="0">
                <a:latin typeface="+mn-lt"/>
              </a:rPr>
              <a:t>T</a:t>
            </a:r>
            <a:r>
              <a:rPr lang="en-US" sz="1800" b="1" baseline="-25000" dirty="0">
                <a:latin typeface="+mn-lt"/>
              </a:rPr>
              <a:t>CM</a:t>
            </a:r>
            <a:r>
              <a:rPr lang="en-US" sz="1800" b="1" dirty="0">
                <a:latin typeface="+mn-lt"/>
              </a:rPr>
              <a:t>/T</a:t>
            </a:r>
            <a:r>
              <a:rPr lang="en-US" sz="1800" b="1" baseline="-25000" dirty="0">
                <a:latin typeface="+mn-lt"/>
              </a:rPr>
              <a:t>EM</a:t>
            </a:r>
            <a:r>
              <a:rPr lang="en-US" sz="1800" b="1" dirty="0">
                <a:latin typeface="+mn-lt"/>
              </a:rPr>
              <a:t> Ratio on CD4+ and CD8+.</a:t>
            </a:r>
            <a:r>
              <a:rPr lang="en-US" sz="1800" dirty="0">
                <a:latin typeface="+mn-lt"/>
              </a:rPr>
              <a:t> Different CAR T cells were expanded for 12 days with T cell media +100 U/ml of IL-2. then CAR T cells were incubated a different E:T ratios in vitro with ROR1</a:t>
            </a:r>
            <a:r>
              <a:rPr lang="en-US" sz="1800" baseline="30000" dirty="0">
                <a:latin typeface="+mn-lt"/>
              </a:rPr>
              <a:t>+ </a:t>
            </a:r>
            <a:r>
              <a:rPr lang="en-US" sz="1800" dirty="0">
                <a:latin typeface="+mn-lt"/>
              </a:rPr>
              <a:t>target cells for 5 consecutive days, following by flow cytometry characterization of CAR+ T cell profile. Abbreviations: *: </a:t>
            </a:r>
            <a:r>
              <a:rPr lang="en-US" sz="1800" i="1" dirty="0">
                <a:latin typeface="+mn-lt"/>
              </a:rPr>
              <a:t>p-value</a:t>
            </a:r>
            <a:r>
              <a:rPr lang="en-US" sz="1800" dirty="0">
                <a:latin typeface="+mn-lt"/>
              </a:rPr>
              <a:t>: &lt;0.001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08819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0C323953-2FCD-F6FD-6CEF-F695CF7162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87038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+mn-lt"/>
              </a:rPr>
              <a:t>Supplementary Table 3. </a:t>
            </a:r>
            <a:r>
              <a:rPr lang="en-US" sz="2400" dirty="0">
                <a:latin typeface="+mn-lt"/>
              </a:rPr>
              <a:t>CD4/CD8% and T cell profile after 12-day expansion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C4C7AB4-EA07-3E83-B72E-37478FC95C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0971401"/>
              </p:ext>
            </p:extLst>
          </p:nvPr>
        </p:nvGraphicFramePr>
        <p:xfrm>
          <a:off x="1202428" y="1018309"/>
          <a:ext cx="9787144" cy="4343305"/>
        </p:xfrm>
        <a:graphic>
          <a:graphicData uri="http://schemas.openxmlformats.org/drawingml/2006/table">
            <a:tbl>
              <a:tblPr firstRow="1">
                <a:tableStyleId>{F5AB1C69-6EDB-4FF4-983F-18BD219EF322}</a:tableStyleId>
              </a:tblPr>
              <a:tblGrid>
                <a:gridCol w="1413164">
                  <a:extLst>
                    <a:ext uri="{9D8B030D-6E8A-4147-A177-3AD203B41FA5}">
                      <a16:colId xmlns:a16="http://schemas.microsoft.com/office/drawing/2014/main" val="4141088465"/>
                    </a:ext>
                  </a:extLst>
                </a:gridCol>
                <a:gridCol w="1340427">
                  <a:extLst>
                    <a:ext uri="{9D8B030D-6E8A-4147-A177-3AD203B41FA5}">
                      <a16:colId xmlns:a16="http://schemas.microsoft.com/office/drawing/2014/main" val="2429498705"/>
                    </a:ext>
                  </a:extLst>
                </a:gridCol>
                <a:gridCol w="1141148">
                  <a:extLst>
                    <a:ext uri="{9D8B030D-6E8A-4147-A177-3AD203B41FA5}">
                      <a16:colId xmlns:a16="http://schemas.microsoft.com/office/drawing/2014/main" val="914583955"/>
                    </a:ext>
                  </a:extLst>
                </a:gridCol>
                <a:gridCol w="1178481">
                  <a:extLst>
                    <a:ext uri="{9D8B030D-6E8A-4147-A177-3AD203B41FA5}">
                      <a16:colId xmlns:a16="http://schemas.microsoft.com/office/drawing/2014/main" val="2683092500"/>
                    </a:ext>
                  </a:extLst>
                </a:gridCol>
                <a:gridCol w="1178481">
                  <a:extLst>
                    <a:ext uri="{9D8B030D-6E8A-4147-A177-3AD203B41FA5}">
                      <a16:colId xmlns:a16="http://schemas.microsoft.com/office/drawing/2014/main" val="1595216735"/>
                    </a:ext>
                  </a:extLst>
                </a:gridCol>
                <a:gridCol w="1178481">
                  <a:extLst>
                    <a:ext uri="{9D8B030D-6E8A-4147-A177-3AD203B41FA5}">
                      <a16:colId xmlns:a16="http://schemas.microsoft.com/office/drawing/2014/main" val="3925343631"/>
                    </a:ext>
                  </a:extLst>
                </a:gridCol>
                <a:gridCol w="1339745">
                  <a:extLst>
                    <a:ext uri="{9D8B030D-6E8A-4147-A177-3AD203B41FA5}">
                      <a16:colId xmlns:a16="http://schemas.microsoft.com/office/drawing/2014/main" val="17228122"/>
                    </a:ext>
                  </a:extLst>
                </a:gridCol>
                <a:gridCol w="1017217">
                  <a:extLst>
                    <a:ext uri="{9D8B030D-6E8A-4147-A177-3AD203B41FA5}">
                      <a16:colId xmlns:a16="http://schemas.microsoft.com/office/drawing/2014/main" val="78381392"/>
                    </a:ext>
                  </a:extLst>
                </a:gridCol>
              </a:tblGrid>
              <a:tr h="81291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T cell profile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Fresh T cells 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UTD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ROR1.B𝜁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ROR1.IB𝜁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ROR1.IO𝜁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ROR1.28B𝜁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61818445"/>
                  </a:ext>
                </a:extLst>
              </a:tr>
              <a:tr h="3227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CM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27.3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73.4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89.8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96.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78.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87.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rgbClr val="0432FF"/>
                          </a:solidFill>
                          <a:effectLst/>
                        </a:rPr>
                        <a:t>CD4</a:t>
                      </a:r>
                      <a:endParaRPr lang="en-US" sz="1800" b="1" i="0" u="none" strike="noStrike" dirty="0">
                        <a:solidFill>
                          <a:srgbClr val="0432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54866410"/>
                  </a:ext>
                </a:extLst>
              </a:tr>
              <a:tr h="3227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EM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21.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20.4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1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3.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21.4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12.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3686640"/>
                  </a:ext>
                </a:extLst>
              </a:tr>
              <a:tr h="3227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CM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21.9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48.8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80.2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82.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76.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7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rgbClr val="0432FF"/>
                          </a:solidFill>
                          <a:effectLst/>
                        </a:rPr>
                        <a:t>CD8</a:t>
                      </a:r>
                      <a:endParaRPr lang="en-US" sz="1800" b="1" i="0" u="none" strike="noStrike" dirty="0">
                        <a:solidFill>
                          <a:srgbClr val="0432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36553974"/>
                  </a:ext>
                </a:extLst>
              </a:tr>
              <a:tr h="3227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EM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14.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</a:rPr>
                        <a:t>12.1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9.6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16.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10.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12.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835729"/>
                  </a:ext>
                </a:extLst>
              </a:tr>
              <a:tr h="322778">
                <a:tc>
                  <a:txBody>
                    <a:bodyPr/>
                    <a:lstStyle/>
                    <a:p>
                      <a:pPr algn="ctr" fontAlgn="ctr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47514106"/>
                  </a:ext>
                </a:extLst>
              </a:tr>
              <a:tr h="1270941">
                <a:tc rowSpan="3" grid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CD4/CD8 %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144" marR="9525" marT="9525" marB="0" anchor="ctr"/>
                </a:tc>
                <a:tc rowSpan="3" hMerge="1">
                  <a:txBody>
                    <a:bodyPr/>
                    <a:lstStyle/>
                    <a:p>
                      <a:pPr algn="ctr" fontAlgn="ctr"/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UTD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ROR1.B𝜁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ROR1.IB𝜁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ROR1.IO𝜁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</a:rPr>
                        <a:t>ROR1.28B𝜁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97900328"/>
                  </a:ext>
                </a:extLst>
              </a:tr>
              <a:tr h="322778">
                <a:tc gridSpan="2" vMerge="1">
                  <a:txBody>
                    <a:bodyPr/>
                    <a:lstStyle/>
                    <a:p>
                      <a:pPr algn="ctr" fontAlgn="ctr"/>
                      <a:endParaRPr lang="en-US" sz="1800" b="1" i="0" u="none" strike="noStrike" dirty="0">
                        <a:solidFill>
                          <a:srgbClr val="0432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 vMerge="1">
                  <a:txBody>
                    <a:bodyPr/>
                    <a:lstStyle/>
                    <a:p>
                      <a:pPr algn="ctr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38.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6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63.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71.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4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rgbClr val="0432FF"/>
                          </a:solidFill>
                          <a:effectLst/>
                        </a:rPr>
                        <a:t>CD4 %</a:t>
                      </a:r>
                      <a:endParaRPr lang="en-US" sz="1800" b="1" i="0" u="none" strike="noStrike" dirty="0">
                        <a:solidFill>
                          <a:srgbClr val="0432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92956692"/>
                  </a:ext>
                </a:extLst>
              </a:tr>
              <a:tr h="322778">
                <a:tc gridSpan="2" vMerge="1">
                  <a:txBody>
                    <a:bodyPr/>
                    <a:lstStyle/>
                    <a:p>
                      <a:pPr algn="ctr" fontAlgn="ctr"/>
                      <a:endParaRPr lang="en-US" sz="1800" b="1" i="0" u="none" strike="noStrike" dirty="0">
                        <a:solidFill>
                          <a:srgbClr val="0432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 vMerge="1">
                  <a:txBody>
                    <a:bodyPr/>
                    <a:lstStyle/>
                    <a:p>
                      <a:pPr algn="ctr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61.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3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36.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28.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>
                          <a:effectLst/>
                        </a:rPr>
                        <a:t>5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solidFill>
                            <a:srgbClr val="0432FF"/>
                          </a:solidFill>
                          <a:effectLst/>
                        </a:rPr>
                        <a:t>CD8 %</a:t>
                      </a:r>
                      <a:endParaRPr lang="en-US" sz="1800" b="1" i="0" u="none" strike="noStrike" dirty="0">
                        <a:solidFill>
                          <a:srgbClr val="0432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7388343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44ECFC77-2D88-43A1-D3D8-300C5686A426}"/>
              </a:ext>
            </a:extLst>
          </p:cNvPr>
          <p:cNvSpPr txBox="1"/>
          <p:nvPr/>
        </p:nvSpPr>
        <p:spPr>
          <a:xfrm>
            <a:off x="1143000" y="5617029"/>
            <a:ext cx="1007472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table 3. </a:t>
            </a:r>
            <a:r>
              <a:rPr lang="en-US" sz="1800" b="1" dirty="0">
                <a:latin typeface="+mn-lt"/>
              </a:rPr>
              <a:t>CD4/CD8% and T cell profile after 12-day expansion.</a:t>
            </a:r>
            <a:r>
              <a:rPr lang="en-US" sz="1800" dirty="0">
                <a:latin typeface="+mn-lt"/>
              </a:rPr>
              <a:t> CAR T cells were expanded for 12 days with T cell media +100 U/ml of IL-2. 1e</a:t>
            </a:r>
            <a:r>
              <a:rPr lang="en-US" sz="1800" baseline="30000" dirty="0">
                <a:latin typeface="+mn-lt"/>
              </a:rPr>
              <a:t>6 </a:t>
            </a:r>
            <a:r>
              <a:rPr lang="en-US" dirty="0"/>
              <a:t>CAR T cells were use for T cell profile via flow cytometry. </a:t>
            </a:r>
          </a:p>
        </p:txBody>
      </p:sp>
    </p:spTree>
    <p:extLst>
      <p:ext uri="{BB962C8B-B14F-4D97-AF65-F5344CB8AC3E}">
        <p14:creationId xmlns:p14="http://schemas.microsoft.com/office/powerpoint/2010/main" val="40196990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0C323953-2FCD-F6FD-6CEF-F695CF7162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87038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+mn-lt"/>
              </a:rPr>
              <a:t>Supplementary Figure 4. </a:t>
            </a:r>
            <a:r>
              <a:rPr lang="en-US" sz="2400" dirty="0">
                <a:latin typeface="+mn-lt"/>
              </a:rPr>
              <a:t>Native</a:t>
            </a:r>
            <a:r>
              <a:rPr lang="en-US" sz="2400" b="1" dirty="0">
                <a:latin typeface="+mn-lt"/>
              </a:rPr>
              <a:t> </a:t>
            </a:r>
            <a:r>
              <a:rPr lang="en-US" sz="2400" dirty="0">
                <a:latin typeface="+mn-lt"/>
              </a:rPr>
              <a:t>CD3z/CAR CD3 ratio after 12-day expansio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4ECFC77-2D88-43A1-D3D8-300C5686A426}"/>
              </a:ext>
            </a:extLst>
          </p:cNvPr>
          <p:cNvSpPr txBox="1"/>
          <p:nvPr/>
        </p:nvSpPr>
        <p:spPr>
          <a:xfrm>
            <a:off x="1058636" y="5617029"/>
            <a:ext cx="1007472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 4. </a:t>
            </a:r>
            <a:r>
              <a:rPr lang="en-US" sz="1800" b="1" dirty="0">
                <a:latin typeface="+mn-lt"/>
              </a:rPr>
              <a:t>Native CD3z/CAR CD3 ratio after 12-day expansion.</a:t>
            </a:r>
            <a:r>
              <a:rPr lang="en-US" sz="1800" dirty="0">
                <a:latin typeface="+mn-lt"/>
              </a:rPr>
              <a:t> </a:t>
            </a:r>
            <a:r>
              <a:rPr lang="en-US" dirty="0"/>
              <a:t>Ratio between native CD3 and CAR CD3 for each construct using the density of the western blot band as a reference for calculation. Abbreviations: UTD: untransduced, GAPDH: Glyceraldehyde 3-phosphate dehydrogenase</a:t>
            </a:r>
          </a:p>
        </p:txBody>
      </p:sp>
      <p:pic>
        <p:nvPicPr>
          <p:cNvPr id="4" name="Picture 3" descr="A black background with gray lines&#10;&#10;Description automatically generated">
            <a:extLst>
              <a:ext uri="{FF2B5EF4-FFF2-40B4-BE49-F238E27FC236}">
                <a16:creationId xmlns:a16="http://schemas.microsoft.com/office/drawing/2014/main" id="{3959A190-E597-88A4-1EA4-7CA73E38AF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0937" y="1066800"/>
            <a:ext cx="10057282" cy="45502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0786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a25fff9c-3f63-4fb2-9a8a-d9bdd0321f9a}" enabled="0" method="" siteId="{a25fff9c-3f63-4fb2-9a8a-d9bdd0321f9a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69</TotalTime>
  <Words>515</Words>
  <Application>Microsoft Macintosh PowerPoint</Application>
  <PresentationFormat>Widescreen</PresentationFormat>
  <Paragraphs>146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Cambria Math</vt:lpstr>
      <vt:lpstr>Office Theme</vt:lpstr>
      <vt:lpstr>  ICOS and OX40 tandem co-stimulation enhances CAR T-cell cytotoxicity and promotes a T-cell persistence phenotype</vt:lpstr>
      <vt:lpstr>PowerPoint Presentation</vt:lpstr>
      <vt:lpstr>PowerPoint Presentation</vt:lpstr>
      <vt:lpstr>Supplementary Figure 2. ROR1 3G CAR expression</vt:lpstr>
      <vt:lpstr>Supplementary Figure 3. Mice weight and tumor engraftments curves</vt:lpstr>
      <vt:lpstr>Supplementary Table 2. TCM/TEM Ratio on CD4+ and CD8+ </vt:lpstr>
      <vt:lpstr>Supplementary Table 3. CD4/CD8% and T cell profile after 12-day expansion</vt:lpstr>
      <vt:lpstr>Supplementary Figure 4. Native CD3z/CAR CD3 ratio after 12-day expans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COS-OX40 Supplementary figures</dc:title>
  <dc:creator>Moreno Cortes, Eider F., M.D.</dc:creator>
  <cp:lastModifiedBy>Moreno Cortes, Eider F., M.D.</cp:lastModifiedBy>
  <cp:revision>3</cp:revision>
  <dcterms:created xsi:type="dcterms:W3CDTF">2022-10-18T19:07:25Z</dcterms:created>
  <dcterms:modified xsi:type="dcterms:W3CDTF">2023-07-21T18:42:21Z</dcterms:modified>
</cp:coreProperties>
</file>